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1488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718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6856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4069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7940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1243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7393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780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0315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1657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9620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1136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76D208-315D-4508-94C9-5F2584CD173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EC6AD9-B4F4-47A6-95A6-ED69076C1A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6650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61736" y="967160"/>
            <a:ext cx="4841525" cy="2545680"/>
            <a:chOff x="661736" y="338833"/>
            <a:chExt cx="4841525" cy="2545680"/>
          </a:xfrm>
        </p:grpSpPr>
        <p:sp>
          <p:nvSpPr>
            <p:cNvPr id="17" name="Rectangle 16"/>
            <p:cNvSpPr/>
            <p:nvPr/>
          </p:nvSpPr>
          <p:spPr bwMode="auto">
            <a:xfrm>
              <a:off x="661736" y="713398"/>
              <a:ext cx="425588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1000" spc="20" dirty="0">
                  <a:latin typeface="Courier New" panose="02070309020205020404" pitchFamily="49" charset="0"/>
                  <a:cs typeface="Courier New" panose="02070309020205020404" pitchFamily="49" charset="0"/>
                </a:rPr>
                <a:t>MLPKKSNKFILVLILCAIVFVSAFALNTSGTRSL</a:t>
              </a:r>
              <a:r>
                <a:rPr lang="en-GB" sz="1000" b="1" spc="20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  <a:r>
                <a:rPr lang="en-GB" sz="1000" spc="2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AE</a:t>
              </a:r>
              <a:r>
                <a:rPr lang="en-GB" sz="1000" b="1" spc="20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P</a:t>
              </a:r>
              <a:r>
                <a:rPr lang="en-GB" sz="1000" spc="2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WG</a:t>
              </a:r>
              <a:r>
                <a:rPr lang="en-GB" sz="1000" b="1" spc="20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W</a:t>
              </a:r>
              <a:r>
                <a:rPr lang="en-GB" sz="1000" spc="2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NISKLLF</a:t>
              </a:r>
              <a:endParaRPr lang="en-GB" sz="1000" spc="2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857250" y="338833"/>
              <a:ext cx="64601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GB" sz="1000" b="1" spc="20" dirty="0" smtClean="0">
                  <a:cs typeface="Courier New" pitchFamily="49" charset="0"/>
                </a:rPr>
                <a:t>Peptide </a:t>
              </a:r>
            </a:p>
            <a:p>
              <a:pPr algn="ctr"/>
              <a:r>
                <a:rPr lang="en-GB" sz="1000" b="1" spc="20" dirty="0" smtClean="0">
                  <a:cs typeface="Courier New" pitchFamily="49" charset="0"/>
                </a:rPr>
                <a:t>activity</a:t>
              </a:r>
              <a:endParaRPr lang="en-GB" sz="1000" b="1" baseline="30000" dirty="0"/>
            </a:p>
          </p:txBody>
        </p:sp>
        <p:grpSp>
          <p:nvGrpSpPr>
            <p:cNvPr id="62" name="Group 61"/>
            <p:cNvGrpSpPr/>
            <p:nvPr/>
          </p:nvGrpSpPr>
          <p:grpSpPr>
            <a:xfrm>
              <a:off x="2872851" y="900807"/>
              <a:ext cx="2487640" cy="307777"/>
              <a:chOff x="2327747" y="844039"/>
              <a:chExt cx="2487640" cy="307777"/>
            </a:xfrm>
          </p:grpSpPr>
          <p:sp>
            <p:nvSpPr>
              <p:cNvPr id="4" name="Rectangle 3"/>
              <p:cNvSpPr/>
              <p:nvPr/>
            </p:nvSpPr>
            <p:spPr bwMode="auto">
              <a:xfrm>
                <a:off x="2327747" y="874817"/>
                <a:ext cx="2047950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RSL</a:t>
                </a:r>
                <a:r>
                  <a:rPr lang="en-GB" sz="1000" spc="2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</a:t>
                </a:r>
                <a:r>
                  <a:rPr lang="en-GB" sz="1000" spc="2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AE</a:t>
                </a:r>
                <a:r>
                  <a:rPr lang="en-GB" sz="1000" spc="2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</a:t>
                </a:r>
                <a:r>
                  <a:rPr lang="en-GB" sz="1000" spc="2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WG</a:t>
                </a:r>
                <a:r>
                  <a:rPr lang="en-GB" sz="1000" spc="2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W</a:t>
                </a:r>
                <a:r>
                  <a:rPr lang="en-GB" sz="1000" spc="2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NISKLLF</a:t>
                </a:r>
                <a:endParaRPr lang="en-GB" sz="1000" spc="2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449838" y="844039"/>
                <a:ext cx="36554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++</a:t>
                </a:r>
                <a:endParaRPr lang="en-GB" sz="1400" dirty="0"/>
              </a:p>
            </p:txBody>
          </p:sp>
        </p:grpSp>
        <p:grpSp>
          <p:nvGrpSpPr>
            <p:cNvPr id="61" name="Group 60"/>
            <p:cNvGrpSpPr/>
            <p:nvPr/>
          </p:nvGrpSpPr>
          <p:grpSpPr>
            <a:xfrm>
              <a:off x="3192385" y="1040468"/>
              <a:ext cx="2213663" cy="307777"/>
              <a:chOff x="2647281" y="1029602"/>
              <a:chExt cx="2213663" cy="307777"/>
            </a:xfrm>
          </p:grpSpPr>
          <p:sp>
            <p:nvSpPr>
              <p:cNvPr id="5" name="Rectangle 4"/>
              <p:cNvSpPr/>
              <p:nvPr/>
            </p:nvSpPr>
            <p:spPr bwMode="auto">
              <a:xfrm>
                <a:off x="2647281" y="1060380"/>
                <a:ext cx="1728415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SL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AE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WG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W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NISKLLF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404281" y="1029602"/>
                <a:ext cx="4566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+++</a:t>
                </a:r>
                <a:endParaRPr lang="en-GB" sz="1400" dirty="0"/>
              </a:p>
            </p:txBody>
          </p:sp>
        </p:grpSp>
        <p:grpSp>
          <p:nvGrpSpPr>
            <p:cNvPr id="60" name="Group 59"/>
            <p:cNvGrpSpPr/>
            <p:nvPr/>
          </p:nvGrpSpPr>
          <p:grpSpPr>
            <a:xfrm>
              <a:off x="3192385" y="1180129"/>
              <a:ext cx="2168106" cy="307777"/>
              <a:chOff x="2647281" y="1215165"/>
              <a:chExt cx="2168106" cy="307777"/>
            </a:xfrm>
          </p:grpSpPr>
          <p:sp>
            <p:nvSpPr>
              <p:cNvPr id="6" name="Rectangle 5"/>
              <p:cNvSpPr/>
              <p:nvPr/>
            </p:nvSpPr>
            <p:spPr bwMode="auto">
              <a:xfrm>
                <a:off x="2647281" y="1245943"/>
                <a:ext cx="1728415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AE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WG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W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NISKLLF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449838" y="1215165"/>
                <a:ext cx="36554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++</a:t>
                </a:r>
                <a:endParaRPr lang="en-GB" sz="1400" dirty="0"/>
              </a:p>
            </p:txBody>
          </p:sp>
        </p:grpSp>
        <p:grpSp>
          <p:nvGrpSpPr>
            <p:cNvPr id="59" name="Group 58"/>
            <p:cNvGrpSpPr/>
            <p:nvPr/>
          </p:nvGrpSpPr>
          <p:grpSpPr>
            <a:xfrm>
              <a:off x="3192385" y="1319790"/>
              <a:ext cx="2168106" cy="307777"/>
              <a:chOff x="2647281" y="1400728"/>
              <a:chExt cx="2168106" cy="307777"/>
            </a:xfrm>
          </p:grpSpPr>
          <p:sp>
            <p:nvSpPr>
              <p:cNvPr id="7" name="Rectangle 6"/>
              <p:cNvSpPr/>
              <p:nvPr/>
            </p:nvSpPr>
            <p:spPr bwMode="auto">
              <a:xfrm>
                <a:off x="2647281" y="1431506"/>
                <a:ext cx="1728415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E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WG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W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NISKLLF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4449838" y="1400728"/>
                <a:ext cx="36554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++</a:t>
                </a:r>
                <a:endParaRPr lang="en-GB" sz="1400" dirty="0"/>
              </a:p>
            </p:txBody>
          </p:sp>
        </p:grpSp>
        <p:grpSp>
          <p:nvGrpSpPr>
            <p:cNvPr id="58" name="Group 57"/>
            <p:cNvGrpSpPr/>
            <p:nvPr/>
          </p:nvGrpSpPr>
          <p:grpSpPr>
            <a:xfrm>
              <a:off x="3192385" y="1459451"/>
              <a:ext cx="2104915" cy="307777"/>
              <a:chOff x="2647281" y="1586291"/>
              <a:chExt cx="2104915" cy="307777"/>
            </a:xfrm>
          </p:grpSpPr>
          <p:sp>
            <p:nvSpPr>
              <p:cNvPr id="8" name="Rectangle 7"/>
              <p:cNvSpPr/>
              <p:nvPr/>
            </p:nvSpPr>
            <p:spPr bwMode="auto">
              <a:xfrm>
                <a:off x="2647281" y="1617069"/>
                <a:ext cx="1728415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WG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W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NISKLLF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4513028" y="1586291"/>
                <a:ext cx="2391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-</a:t>
                </a:r>
                <a:endParaRPr lang="en-GB" sz="1400" dirty="0"/>
              </a:p>
            </p:txBody>
          </p:sp>
        </p:grpSp>
        <p:grpSp>
          <p:nvGrpSpPr>
            <p:cNvPr id="57" name="Group 56"/>
            <p:cNvGrpSpPr/>
            <p:nvPr/>
          </p:nvGrpSpPr>
          <p:grpSpPr>
            <a:xfrm>
              <a:off x="3192385" y="2576736"/>
              <a:ext cx="2104915" cy="307777"/>
              <a:chOff x="2647281" y="1771854"/>
              <a:chExt cx="2104915" cy="307777"/>
            </a:xfrm>
          </p:grpSpPr>
          <p:sp>
            <p:nvSpPr>
              <p:cNvPr id="9" name="Rectangle 8"/>
              <p:cNvSpPr/>
              <p:nvPr/>
            </p:nvSpPr>
            <p:spPr bwMode="auto">
              <a:xfrm>
                <a:off x="2647281" y="1802632"/>
                <a:ext cx="1728415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NISKLLF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513028" y="1771854"/>
                <a:ext cx="2391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-</a:t>
                </a:r>
                <a:endParaRPr lang="en-GB" sz="1400" dirty="0"/>
              </a:p>
            </p:txBody>
          </p:sp>
        </p:grpSp>
        <p:grpSp>
          <p:nvGrpSpPr>
            <p:cNvPr id="56" name="Group 55"/>
            <p:cNvGrpSpPr/>
            <p:nvPr/>
          </p:nvGrpSpPr>
          <p:grpSpPr>
            <a:xfrm>
              <a:off x="2350756" y="2437078"/>
              <a:ext cx="2946544" cy="307777"/>
              <a:chOff x="1805652" y="1957417"/>
              <a:chExt cx="2946544" cy="307777"/>
            </a:xfrm>
          </p:grpSpPr>
          <p:sp>
            <p:nvSpPr>
              <p:cNvPr id="14" name="Rectangle 13"/>
              <p:cNvSpPr/>
              <p:nvPr/>
            </p:nvSpPr>
            <p:spPr bwMode="auto">
              <a:xfrm>
                <a:off x="1805652" y="1988195"/>
                <a:ext cx="1623348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SGTRSL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AE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4513028" y="1957417"/>
                <a:ext cx="2391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-</a:t>
                </a:r>
                <a:endParaRPr lang="en-GB" sz="1400" dirty="0"/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2245688" y="2297417"/>
              <a:ext cx="3051612" cy="307777"/>
              <a:chOff x="1700584" y="2142980"/>
              <a:chExt cx="3051612" cy="307777"/>
            </a:xfrm>
          </p:grpSpPr>
          <p:sp>
            <p:nvSpPr>
              <p:cNvPr id="15" name="Rectangle 14"/>
              <p:cNvSpPr/>
              <p:nvPr/>
            </p:nvSpPr>
            <p:spPr bwMode="auto">
              <a:xfrm>
                <a:off x="1700584" y="2173758"/>
                <a:ext cx="1728416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RSL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AE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4513028" y="2142980"/>
                <a:ext cx="2391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-</a:t>
                </a:r>
                <a:endParaRPr lang="en-GB" sz="1400" dirty="0"/>
              </a:p>
            </p:txBody>
          </p:sp>
        </p:grpSp>
        <p:grpSp>
          <p:nvGrpSpPr>
            <p:cNvPr id="54" name="Group 53"/>
            <p:cNvGrpSpPr/>
            <p:nvPr/>
          </p:nvGrpSpPr>
          <p:grpSpPr>
            <a:xfrm>
              <a:off x="2245688" y="2157756"/>
              <a:ext cx="3051612" cy="307777"/>
              <a:chOff x="1700584" y="2328543"/>
              <a:chExt cx="3051612" cy="307777"/>
            </a:xfrm>
          </p:grpSpPr>
          <p:sp>
            <p:nvSpPr>
              <p:cNvPr id="16" name="Rectangle 15"/>
              <p:cNvSpPr/>
              <p:nvPr/>
            </p:nvSpPr>
            <p:spPr bwMode="auto">
              <a:xfrm>
                <a:off x="1700584" y="2359321"/>
                <a:ext cx="1728416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SL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AE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4513028" y="2328543"/>
                <a:ext cx="2391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-</a:t>
                </a:r>
                <a:endParaRPr lang="en-GB" sz="1400" dirty="0"/>
              </a:p>
            </p:txBody>
          </p:sp>
        </p:grpSp>
        <p:grpSp>
          <p:nvGrpSpPr>
            <p:cNvPr id="53" name="Group 52"/>
            <p:cNvGrpSpPr/>
            <p:nvPr/>
          </p:nvGrpSpPr>
          <p:grpSpPr>
            <a:xfrm>
              <a:off x="2638789" y="2018095"/>
              <a:ext cx="2767259" cy="307777"/>
              <a:chOff x="2093685" y="2514106"/>
              <a:chExt cx="2767259" cy="307777"/>
            </a:xfrm>
          </p:grpSpPr>
          <p:sp>
            <p:nvSpPr>
              <p:cNvPr id="10" name="Rectangle 9"/>
              <p:cNvSpPr/>
              <p:nvPr/>
            </p:nvSpPr>
            <p:spPr bwMode="auto">
              <a:xfrm>
                <a:off x="2093685" y="2544884"/>
                <a:ext cx="1728415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RSL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AE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WG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W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4404281" y="2514106"/>
                <a:ext cx="4566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+++</a:t>
                </a:r>
                <a:endParaRPr lang="en-GB" sz="1400" dirty="0"/>
              </a:p>
            </p:txBody>
          </p:sp>
        </p:grpSp>
        <p:grpSp>
          <p:nvGrpSpPr>
            <p:cNvPr id="52" name="Group 51"/>
            <p:cNvGrpSpPr/>
            <p:nvPr/>
          </p:nvGrpSpPr>
          <p:grpSpPr>
            <a:xfrm>
              <a:off x="2638789" y="1878434"/>
              <a:ext cx="2767259" cy="307777"/>
              <a:chOff x="2093685" y="2699669"/>
              <a:chExt cx="2767259" cy="307777"/>
            </a:xfrm>
          </p:grpSpPr>
          <p:sp>
            <p:nvSpPr>
              <p:cNvPr id="11" name="Rectangle 10"/>
              <p:cNvSpPr/>
              <p:nvPr/>
            </p:nvSpPr>
            <p:spPr bwMode="auto">
              <a:xfrm>
                <a:off x="2093685" y="2730447"/>
                <a:ext cx="1728415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SL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AE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WG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W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4404281" y="2699669"/>
                <a:ext cx="4566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+++</a:t>
                </a:r>
                <a:endParaRPr lang="en-GB" sz="1400" dirty="0"/>
              </a:p>
            </p:txBody>
          </p:sp>
        </p:grpSp>
        <p:grpSp>
          <p:nvGrpSpPr>
            <p:cNvPr id="51" name="Group 50"/>
            <p:cNvGrpSpPr/>
            <p:nvPr/>
          </p:nvGrpSpPr>
          <p:grpSpPr>
            <a:xfrm>
              <a:off x="2638789" y="1738773"/>
              <a:ext cx="2767259" cy="307777"/>
              <a:chOff x="2093685" y="2885232"/>
              <a:chExt cx="2767259" cy="307777"/>
            </a:xfrm>
          </p:grpSpPr>
          <p:sp>
            <p:nvSpPr>
              <p:cNvPr id="12" name="Rectangle 11"/>
              <p:cNvSpPr/>
              <p:nvPr/>
            </p:nvSpPr>
            <p:spPr bwMode="auto">
              <a:xfrm>
                <a:off x="2093685" y="2916010"/>
                <a:ext cx="1728415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L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AE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WG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W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4404281" y="2885232"/>
                <a:ext cx="4566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+++</a:t>
                </a:r>
                <a:endParaRPr lang="en-GB" sz="1400" dirty="0"/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2638789" y="1599112"/>
              <a:ext cx="2767259" cy="307777"/>
              <a:chOff x="2093685" y="3070800"/>
              <a:chExt cx="2767259" cy="307777"/>
            </a:xfrm>
          </p:grpSpPr>
          <p:sp>
            <p:nvSpPr>
              <p:cNvPr id="13" name="Rectangle 12"/>
              <p:cNvSpPr/>
              <p:nvPr/>
            </p:nvSpPr>
            <p:spPr bwMode="auto">
              <a:xfrm>
                <a:off x="2093685" y="3101578"/>
                <a:ext cx="1728415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E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</a:t>
                </a:r>
                <a:r>
                  <a:rPr lang="en-GB" sz="1000" spc="2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WG</a:t>
                </a:r>
                <a:r>
                  <a:rPr lang="en-GB" sz="1000" spc="2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W</a:t>
                </a: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4404281" y="3070800"/>
                <a:ext cx="4566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 smtClean="0"/>
                  <a:t>+++</a:t>
                </a:r>
                <a:endParaRPr lang="en-GB" sz="1400" dirty="0"/>
              </a:p>
            </p:txBody>
          </p:sp>
        </p:grpSp>
      </p:grpSp>
      <p:sp>
        <p:nvSpPr>
          <p:cNvPr id="3" name="TextBox 2"/>
          <p:cNvSpPr txBox="1"/>
          <p:nvPr/>
        </p:nvSpPr>
        <p:spPr>
          <a:xfrm>
            <a:off x="163096" y="56456"/>
            <a:ext cx="75488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smtClean="0"/>
              <a:t>Figure </a:t>
            </a:r>
            <a:r>
              <a:rPr lang="en-GB" sz="1200" dirty="0" smtClean="0"/>
              <a:t>S5</a:t>
            </a:r>
            <a:endParaRPr lang="en-GB" sz="1200" dirty="0"/>
          </a:p>
        </p:txBody>
      </p:sp>
      <p:sp>
        <p:nvSpPr>
          <p:cNvPr id="63" name="Rectangle 62"/>
          <p:cNvSpPr/>
          <p:nvPr/>
        </p:nvSpPr>
        <p:spPr>
          <a:xfrm>
            <a:off x="774476" y="3872880"/>
            <a:ext cx="5457040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nthetic peptides alleviat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sr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ediated repression 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lvent formation. </a:t>
            </a: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indicated synthetic peptides dissolved in DMSO were add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CBM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s of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etobutylicum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TL85141-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srB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4 h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 to a final concentration of 10 </a:t>
            </a:r>
            <a:r>
              <a:rPr lang="en-US" sz="1200" dirty="0" err="1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quivalent DMSO controls were performed for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etobutylicum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TL85141 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etobutylicum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TL85141-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srB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 Triplicate cultures were grown for 5 days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final butanol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tre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ability to overcom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sr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ediated repression of butanol formation was scored in comparison to the DMSO controls as follows: -, no significant difference to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etobutylicum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TL85141-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srB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MSO control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+, final butanol levels 40-66% of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etobutylicum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TL85141 DMSO control; +++, final butanol levels 67-100% of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etobutylicum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TL85141 DMSO control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etobutylic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TL85141-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rB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MSO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etobutylic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TL85141 DMSO controls produc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±8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123±17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butanol, respectively. The complet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 is given at the top with the three conserved amino acid positions (leucine, proline, tryptophan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terminal region indicated by bold red lettering.</a:t>
            </a:r>
          </a:p>
        </p:txBody>
      </p:sp>
    </p:spTree>
    <p:extLst>
      <p:ext uri="{BB962C8B-B14F-4D97-AF65-F5344CB8AC3E}">
        <p14:creationId xmlns:p14="http://schemas.microsoft.com/office/powerpoint/2010/main" val="2901969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34</TotalTime>
  <Words>224</Words>
  <Application>Microsoft Office PowerPoint</Application>
  <PresentationFormat>A4 Paper (210x297 mm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ourier New</vt:lpstr>
      <vt:lpstr>Symbol</vt:lpstr>
      <vt:lpstr>Times New Roman</vt:lpstr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zer Klaus</dc:creator>
  <cp:lastModifiedBy>Klaus Winzer</cp:lastModifiedBy>
  <cp:revision>32</cp:revision>
  <dcterms:created xsi:type="dcterms:W3CDTF">2016-11-22T16:34:25Z</dcterms:created>
  <dcterms:modified xsi:type="dcterms:W3CDTF">2020-01-27T11:27:42Z</dcterms:modified>
</cp:coreProperties>
</file>